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867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504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249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7116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41177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022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8123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7245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73272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5899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3366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25993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144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77500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Picture 3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2778" y="160185"/>
            <a:ext cx="2832000" cy="2124000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4566" y="160185"/>
            <a:ext cx="2832000" cy="2124000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991" y="2443508"/>
            <a:ext cx="2832000" cy="2124000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2779" y="2443508"/>
            <a:ext cx="2832000" cy="2124000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4566" y="2443508"/>
            <a:ext cx="2832000" cy="2124000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991" y="160185"/>
            <a:ext cx="2832000" cy="2124000"/>
          </a:xfrm>
          <a:prstGeom prst="rect">
            <a:avLst/>
          </a:prstGeom>
        </p:spPr>
      </p:pic>
      <p:sp>
        <p:nvSpPr>
          <p:cNvPr id="39" name="Title 1"/>
          <p:cNvSpPr txBox="1">
            <a:spLocks/>
          </p:cNvSpPr>
          <p:nvPr/>
        </p:nvSpPr>
        <p:spPr>
          <a:xfrm rot="16200000">
            <a:off x="-739321" y="2803190"/>
            <a:ext cx="1852583" cy="344320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ed64_MN</a:t>
            </a:r>
            <a:endParaRPr lang="en-GB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7" name="Picture 6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98824" y="4726831"/>
            <a:ext cx="2827397" cy="2124000"/>
          </a:xfrm>
          <a:prstGeom prst="rect">
            <a:avLst/>
          </a:prstGeom>
        </p:spPr>
      </p:pic>
      <p:sp>
        <p:nvSpPr>
          <p:cNvPr id="79" name="TextBox 78"/>
          <p:cNvSpPr txBox="1"/>
          <p:nvPr/>
        </p:nvSpPr>
        <p:spPr>
          <a:xfrm>
            <a:off x="3402779" y="-56467"/>
            <a:ext cx="13202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r>
              <a:rPr lang="en-US" sz="1200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stin</a:t>
            </a:r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67</a:t>
            </a: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6284567" y="-56467"/>
            <a:ext cx="1611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r>
              <a:rPr lang="en-US" sz="1200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133</a:t>
            </a:r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ox2</a:t>
            </a: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520991" y="2222325"/>
            <a:ext cx="2360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r>
              <a:rPr lang="en-US" sz="120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mentin</a:t>
            </a:r>
            <a:r>
              <a:rPr lang="en-US" sz="12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ZD9</a:t>
            </a: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402778" y="2222325"/>
            <a:ext cx="9828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r>
              <a:rPr lang="en-US" sz="12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AP</a:t>
            </a: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6284566" y="2222325"/>
            <a:ext cx="13060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r>
              <a:rPr lang="en-US" sz="12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IIITubulin</a:t>
            </a: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520991" y="4512258"/>
            <a:ext cx="1766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r>
              <a:rPr lang="en-US" sz="1200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SEA4</a:t>
            </a:r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lig2</a:t>
            </a: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520992" y="-56467"/>
            <a:ext cx="12186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 control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991" y="4721968"/>
            <a:ext cx="2832000" cy="2124000"/>
          </a:xfrm>
          <a:prstGeom prst="rect">
            <a:avLst/>
          </a:prstGeom>
        </p:spPr>
      </p:pic>
      <p:sp>
        <p:nvSpPr>
          <p:cNvPr id="42" name="TextBox 41"/>
          <p:cNvSpPr txBox="1"/>
          <p:nvPr/>
        </p:nvSpPr>
        <p:spPr>
          <a:xfrm>
            <a:off x="6497198" y="4793328"/>
            <a:ext cx="2498755" cy="769441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stin</a:t>
            </a:r>
            <a:r>
              <a:rPr lang="en-US" sz="1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 	</a:t>
            </a:r>
            <a:r>
              <a:rPr lang="en-US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67	</a:t>
            </a:r>
            <a:r>
              <a:rPr lang="en-US" sz="1000" dirty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33</a:t>
            </a:r>
          </a:p>
          <a:p>
            <a:r>
              <a:rPr lang="en-US" sz="1000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x2	</a:t>
            </a:r>
            <a:r>
              <a:rPr lang="en-US" sz="1000" dirty="0">
                <a:solidFill>
                  <a:srgbClr val="92D05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mentin	</a:t>
            </a:r>
            <a:r>
              <a:rPr lang="en-US" sz="10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GB" sz="10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ZD9</a:t>
            </a:r>
          </a:p>
          <a:p>
            <a:r>
              <a:rPr lang="en-US" sz="10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P	</a:t>
            </a:r>
            <a:r>
              <a:rPr lang="en-US" sz="10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IITubulin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US" sz="1000" dirty="0">
                <a:solidFill>
                  <a:srgbClr val="CC00CC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GB" sz="1000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EA4</a:t>
            </a:r>
          </a:p>
          <a:p>
            <a:r>
              <a:rPr lang="en-US" sz="1000" dirty="0">
                <a:solidFill>
                  <a:srgbClr val="7030A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lig2</a:t>
            </a:r>
          </a:p>
          <a:p>
            <a:endParaRPr lang="en-GB" sz="1000" dirty="0">
              <a:solidFill>
                <a:srgbClr val="7030A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8569645" y="4516351"/>
            <a:ext cx="5469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µ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Straight Connector 48"/>
          <p:cNvCxnSpPr/>
          <p:nvPr/>
        </p:nvCxnSpPr>
        <p:spPr>
          <a:xfrm>
            <a:off x="8664928" y="4718770"/>
            <a:ext cx="4104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" name="Group 10"/>
          <p:cNvGrpSpPr/>
          <p:nvPr/>
        </p:nvGrpSpPr>
        <p:grpSpPr>
          <a:xfrm>
            <a:off x="6476636" y="5961327"/>
            <a:ext cx="856838" cy="826764"/>
            <a:chOff x="6949897" y="5464619"/>
            <a:chExt cx="856838" cy="826764"/>
          </a:xfrm>
        </p:grpSpPr>
        <p:sp>
          <p:nvSpPr>
            <p:cNvPr id="44" name="Rectangle 43"/>
            <p:cNvSpPr/>
            <p:nvPr/>
          </p:nvSpPr>
          <p:spPr>
            <a:xfrm>
              <a:off x="7198954" y="5464619"/>
              <a:ext cx="558010" cy="60381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cxnSp>
          <p:nvCxnSpPr>
            <p:cNvPr id="6" name="Straight Arrow Connector 5"/>
            <p:cNvCxnSpPr/>
            <p:nvPr/>
          </p:nvCxnSpPr>
          <p:spPr>
            <a:xfrm>
              <a:off x="7198954" y="6103087"/>
              <a:ext cx="55801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Arrow Connector 7"/>
            <p:cNvCxnSpPr/>
            <p:nvPr/>
          </p:nvCxnSpPr>
          <p:spPr>
            <a:xfrm flipV="1">
              <a:off x="7151714" y="5464619"/>
              <a:ext cx="0" cy="60381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7149183" y="6045162"/>
              <a:ext cx="65755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7.42</a:t>
              </a:r>
              <a:r>
                <a:rPr lang="en-US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µ</a:t>
              </a: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6744232" y="5670284"/>
              <a:ext cx="65755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4.75</a:t>
              </a:r>
              <a:r>
                <a:rPr lang="en-US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µ</a:t>
              </a: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6400270" y="5418525"/>
            <a:ext cx="13292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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marker detected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7283706" y="5985409"/>
            <a:ext cx="1324757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Times New Roman" panose="02020603050405020304" pitchFamily="18" charset="0"/>
                <a:cs typeface="Times New Roman" panose="02020603050405020304" pitchFamily="18" charset="0"/>
              </a:rPr>
              <a:t>The dimensions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a single sub-area within the grid  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6400270" y="4741653"/>
            <a:ext cx="2595680" cy="9230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Rectangle 36"/>
          <p:cNvSpPr/>
          <p:nvPr/>
        </p:nvSpPr>
        <p:spPr>
          <a:xfrm>
            <a:off x="6404057" y="5828557"/>
            <a:ext cx="2595680" cy="9230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7" name="Straight Connector 6"/>
          <p:cNvCxnSpPr/>
          <p:nvPr/>
        </p:nvCxnSpPr>
        <p:spPr>
          <a:xfrm>
            <a:off x="413084" y="160188"/>
            <a:ext cx="0" cy="66978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3503362" y="4512258"/>
            <a:ext cx="1766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nal grid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1705" y="3586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3251351" y="449371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39136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9</TotalTime>
  <Words>31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apInfo Cartographic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EMA MOHAMAD *************** HUSSAIN</dc:creator>
  <cp:lastModifiedBy>DEEMA MOHAMAD *************** HUSSAIN</cp:lastModifiedBy>
  <cp:revision>20</cp:revision>
  <dcterms:created xsi:type="dcterms:W3CDTF">2016-07-28T09:26:46Z</dcterms:created>
  <dcterms:modified xsi:type="dcterms:W3CDTF">2018-05-03T09:32:06Z</dcterms:modified>
</cp:coreProperties>
</file>